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EB90670-C0A7-4CE7-95D0-A6C0892A6F70}" v="17" dt="2025-12-07T15:25:41.6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69" d="100"/>
          <a:sy n="69" d="100"/>
        </p:scale>
        <p:origin x="50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maculada Navarro Lérida" userId="a709f962-7a6b-4e29-94b4-34e94bec1ace" providerId="ADAL" clId="{CB1B0F86-67B5-48D7-A333-4A72740E5CDB}"/>
    <pc:docChg chg="undo custSel addSld modSld">
      <pc:chgData name="Inmaculada Navarro Lérida" userId="a709f962-7a6b-4e29-94b4-34e94bec1ace" providerId="ADAL" clId="{CB1B0F86-67B5-48D7-A333-4A72740E5CDB}" dt="2025-12-07T15:25:47.563" v="140" actId="20577"/>
      <pc:docMkLst>
        <pc:docMk/>
      </pc:docMkLst>
      <pc:sldChg chg="addSp delSp modSp mod">
        <pc:chgData name="Inmaculada Navarro Lérida" userId="a709f962-7a6b-4e29-94b4-34e94bec1ace" providerId="ADAL" clId="{CB1B0F86-67B5-48D7-A333-4A72740E5CDB}" dt="2025-12-07T15:25:47.563" v="140" actId="20577"/>
        <pc:sldMkLst>
          <pc:docMk/>
          <pc:sldMk cId="2265113984" sldId="256"/>
        </pc:sldMkLst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6" creationId="{5E1CB1D0-B312-11B2-91F0-2EAB6CE4FD23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7" creationId="{3808D4E4-8747-973E-1F47-3284DD9A65EB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8" creationId="{B8FBB50D-80A9-B301-CF71-F1AA05F85276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9" creationId="{08F6ED5D-B379-FB4C-71E1-0407216FDC4C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12" creationId="{8534CD4A-F0B1-82A9-1390-21AA672DF6AA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13" creationId="{B38144EF-7A50-49E8-C695-781284662126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14" creationId="{BFE32C3E-26C2-1C06-BDBC-F31B057AB7BE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15" creationId="{306D9507-402F-30B0-31A6-D9466B59F29E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20" creationId="{B71237DC-2AE1-57E3-4891-C704E4B348AD}"/>
          </ac:spMkLst>
        </pc:spChg>
        <pc:spChg chg="del">
          <ac:chgData name="Inmaculada Navarro Lérida" userId="a709f962-7a6b-4e29-94b4-34e94bec1ace" providerId="ADAL" clId="{CB1B0F86-67B5-48D7-A333-4A72740E5CDB}" dt="2025-12-07T15:23:12.220" v="52" actId="478"/>
          <ac:spMkLst>
            <pc:docMk/>
            <pc:sldMk cId="2265113984" sldId="256"/>
            <ac:spMk id="21" creationId="{0239B7A1-1C5D-904D-7F0E-B0A8692A53EB}"/>
          </ac:spMkLst>
        </pc:spChg>
        <pc:spChg chg="del">
          <ac:chgData name="Inmaculada Navarro Lérida" userId="a709f962-7a6b-4e29-94b4-34e94bec1ace" providerId="ADAL" clId="{CB1B0F86-67B5-48D7-A333-4A72740E5CDB}" dt="2025-12-07T15:23:13.663" v="53" actId="478"/>
          <ac:spMkLst>
            <pc:docMk/>
            <pc:sldMk cId="2265113984" sldId="256"/>
            <ac:spMk id="22" creationId="{45834FAF-5976-B966-A827-117206369A12}"/>
          </ac:spMkLst>
        </pc:spChg>
        <pc:spChg chg="del">
          <ac:chgData name="Inmaculada Navarro Lérida" userId="a709f962-7a6b-4e29-94b4-34e94bec1ace" providerId="ADAL" clId="{CB1B0F86-67B5-48D7-A333-4A72740E5CDB}" dt="2025-12-07T15:23:08.935" v="50" actId="478"/>
          <ac:spMkLst>
            <pc:docMk/>
            <pc:sldMk cId="2265113984" sldId="256"/>
            <ac:spMk id="23" creationId="{41E64A9E-1433-C8C1-805F-C91B1E0B0430}"/>
          </ac:spMkLst>
        </pc:spChg>
        <pc:spChg chg="add mod">
          <ac:chgData name="Inmaculada Navarro Lérida" userId="a709f962-7a6b-4e29-94b4-34e94bec1ace" providerId="ADAL" clId="{CB1B0F86-67B5-48D7-A333-4A72740E5CDB}" dt="2025-12-07T15:23:41.253" v="65" actId="1076"/>
          <ac:spMkLst>
            <pc:docMk/>
            <pc:sldMk cId="2265113984" sldId="256"/>
            <ac:spMk id="24" creationId="{ECAB8D97-4B70-876C-F8B2-AB06E20ECCAF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25" creationId="{05E4F7AA-445A-C965-FEC0-43DD11454190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26" creationId="{2BA0C1C0-7714-13F5-EA18-1741B4F6A010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27" creationId="{22AF1FA8-8C6E-37A9-46BA-2FAD8113C1D6}"/>
          </ac:spMkLst>
        </pc:spChg>
        <pc:spChg chg="del">
          <ac:chgData name="Inmaculada Navarro Lérida" userId="a709f962-7a6b-4e29-94b4-34e94bec1ace" providerId="ADAL" clId="{CB1B0F86-67B5-48D7-A333-4A72740E5CDB}" dt="2025-12-07T15:18:21.264" v="1" actId="478"/>
          <ac:spMkLst>
            <pc:docMk/>
            <pc:sldMk cId="2265113984" sldId="256"/>
            <ac:spMk id="28" creationId="{30C67C25-8EEA-1977-8C7E-FD1F62E9E5A8}"/>
          </ac:spMkLst>
        </pc:spChg>
        <pc:spChg chg="add mod">
          <ac:chgData name="Inmaculada Navarro Lérida" userId="a709f962-7a6b-4e29-94b4-34e94bec1ace" providerId="ADAL" clId="{CB1B0F86-67B5-48D7-A333-4A72740E5CDB}" dt="2025-12-07T15:23:50.252" v="71" actId="20577"/>
          <ac:spMkLst>
            <pc:docMk/>
            <pc:sldMk cId="2265113984" sldId="256"/>
            <ac:spMk id="30" creationId="{99654C19-C3BB-E974-4F54-CB2813EA16A5}"/>
          </ac:spMkLst>
        </pc:spChg>
        <pc:spChg chg="add mod">
          <ac:chgData name="Inmaculada Navarro Lérida" userId="a709f962-7a6b-4e29-94b4-34e94bec1ace" providerId="ADAL" clId="{CB1B0F86-67B5-48D7-A333-4A72740E5CDB}" dt="2025-12-07T15:23:59.775" v="77" actId="20577"/>
          <ac:spMkLst>
            <pc:docMk/>
            <pc:sldMk cId="2265113984" sldId="256"/>
            <ac:spMk id="32" creationId="{171B5CF1-E4E7-F2F6-A47A-3C9F42D47206}"/>
          </ac:spMkLst>
        </pc:spChg>
        <pc:spChg chg="add mod">
          <ac:chgData name="Inmaculada Navarro Lérida" userId="a709f962-7a6b-4e29-94b4-34e94bec1ace" providerId="ADAL" clId="{CB1B0F86-67B5-48D7-A333-4A72740E5CDB}" dt="2025-12-07T15:24:09.911" v="83" actId="20577"/>
          <ac:spMkLst>
            <pc:docMk/>
            <pc:sldMk cId="2265113984" sldId="256"/>
            <ac:spMk id="34" creationId="{739FA583-71D6-94E2-54EA-E3DA178298B9}"/>
          </ac:spMkLst>
        </pc:spChg>
        <pc:spChg chg="add mod">
          <ac:chgData name="Inmaculada Navarro Lérida" userId="a709f962-7a6b-4e29-94b4-34e94bec1ace" providerId="ADAL" clId="{CB1B0F86-67B5-48D7-A333-4A72740E5CDB}" dt="2025-12-07T15:24:27.886" v="101" actId="20577"/>
          <ac:spMkLst>
            <pc:docMk/>
            <pc:sldMk cId="2265113984" sldId="256"/>
            <ac:spMk id="36" creationId="{E392F076-F41E-A84D-E226-1878E2D1B3DE}"/>
          </ac:spMkLst>
        </pc:spChg>
        <pc:spChg chg="add mod">
          <ac:chgData name="Inmaculada Navarro Lérida" userId="a709f962-7a6b-4e29-94b4-34e94bec1ace" providerId="ADAL" clId="{CB1B0F86-67B5-48D7-A333-4A72740E5CDB}" dt="2025-12-07T15:24:45.171" v="104" actId="692"/>
          <ac:spMkLst>
            <pc:docMk/>
            <pc:sldMk cId="2265113984" sldId="256"/>
            <ac:spMk id="37" creationId="{BF92DF8A-1BC9-4F4C-B40B-EBECADDA3165}"/>
          </ac:spMkLst>
        </pc:spChg>
        <pc:spChg chg="add mod">
          <ac:chgData name="Inmaculada Navarro Lérida" userId="a709f962-7a6b-4e29-94b4-34e94bec1ace" providerId="ADAL" clId="{CB1B0F86-67B5-48D7-A333-4A72740E5CDB}" dt="2025-12-07T15:24:51.966" v="107" actId="1076"/>
          <ac:spMkLst>
            <pc:docMk/>
            <pc:sldMk cId="2265113984" sldId="256"/>
            <ac:spMk id="38" creationId="{E7D03140-4342-6580-BE31-F295A7C504B4}"/>
          </ac:spMkLst>
        </pc:spChg>
        <pc:spChg chg="add mod">
          <ac:chgData name="Inmaculada Navarro Lérida" userId="a709f962-7a6b-4e29-94b4-34e94bec1ace" providerId="ADAL" clId="{CB1B0F86-67B5-48D7-A333-4A72740E5CDB}" dt="2025-12-07T15:24:58.140" v="109" actId="1076"/>
          <ac:spMkLst>
            <pc:docMk/>
            <pc:sldMk cId="2265113984" sldId="256"/>
            <ac:spMk id="39" creationId="{AA24F812-6324-D67B-EB43-12493F7B737C}"/>
          </ac:spMkLst>
        </pc:spChg>
        <pc:spChg chg="add mod">
          <ac:chgData name="Inmaculada Navarro Lérida" userId="a709f962-7a6b-4e29-94b4-34e94bec1ace" providerId="ADAL" clId="{CB1B0F86-67B5-48D7-A333-4A72740E5CDB}" dt="2025-12-07T15:25:03.745" v="111" actId="1076"/>
          <ac:spMkLst>
            <pc:docMk/>
            <pc:sldMk cId="2265113984" sldId="256"/>
            <ac:spMk id="40" creationId="{CA21EAE1-1FD7-A64C-B461-82195A63E1D2}"/>
          </ac:spMkLst>
        </pc:spChg>
        <pc:spChg chg="add mod">
          <ac:chgData name="Inmaculada Navarro Lérida" userId="a709f962-7a6b-4e29-94b4-34e94bec1ace" providerId="ADAL" clId="{CB1B0F86-67B5-48D7-A333-4A72740E5CDB}" dt="2025-12-07T15:25:08.067" v="113" actId="1076"/>
          <ac:spMkLst>
            <pc:docMk/>
            <pc:sldMk cId="2265113984" sldId="256"/>
            <ac:spMk id="41" creationId="{CBE00172-D586-8DC8-5C88-508AC6188019}"/>
          </ac:spMkLst>
        </pc:spChg>
        <pc:spChg chg="add mod">
          <ac:chgData name="Inmaculada Navarro Lérida" userId="a709f962-7a6b-4e29-94b4-34e94bec1ace" providerId="ADAL" clId="{CB1B0F86-67B5-48D7-A333-4A72740E5CDB}" dt="2025-12-07T15:25:24.726" v="125" actId="1076"/>
          <ac:spMkLst>
            <pc:docMk/>
            <pc:sldMk cId="2265113984" sldId="256"/>
            <ac:spMk id="42" creationId="{3FA3C7F8-0E96-4C51-1066-17BAC6C77ECF}"/>
          </ac:spMkLst>
        </pc:spChg>
        <pc:spChg chg="add mod">
          <ac:chgData name="Inmaculada Navarro Lérida" userId="a709f962-7a6b-4e29-94b4-34e94bec1ace" providerId="ADAL" clId="{CB1B0F86-67B5-48D7-A333-4A72740E5CDB}" dt="2025-12-07T15:25:35.805" v="130" actId="20577"/>
          <ac:spMkLst>
            <pc:docMk/>
            <pc:sldMk cId="2265113984" sldId="256"/>
            <ac:spMk id="43" creationId="{E2C513AF-A9A1-92E9-05D0-30A9FA14A1C6}"/>
          </ac:spMkLst>
        </pc:spChg>
        <pc:spChg chg="add mod">
          <ac:chgData name="Inmaculada Navarro Lérida" userId="a709f962-7a6b-4e29-94b4-34e94bec1ace" providerId="ADAL" clId="{CB1B0F86-67B5-48D7-A333-4A72740E5CDB}" dt="2025-12-07T15:25:47.563" v="140" actId="20577"/>
          <ac:spMkLst>
            <pc:docMk/>
            <pc:sldMk cId="2265113984" sldId="256"/>
            <ac:spMk id="44" creationId="{4CDBCC1A-C6C8-B730-5768-CB392783E359}"/>
          </ac:spMkLst>
        </pc:spChg>
        <pc:picChg chg="add mod modCrop">
          <ac:chgData name="Inmaculada Navarro Lérida" userId="a709f962-7a6b-4e29-94b4-34e94bec1ace" providerId="ADAL" clId="{CB1B0F86-67B5-48D7-A333-4A72740E5CDB}" dt="2025-12-07T15:23:18.985" v="54" actId="1076"/>
          <ac:picMkLst>
            <pc:docMk/>
            <pc:sldMk cId="2265113984" sldId="256"/>
            <ac:picMk id="2" creationId="{4B40D47B-FC90-73C2-E7E3-A66FB29748CB}"/>
          </ac:picMkLst>
        </pc:picChg>
        <pc:picChg chg="add del mod">
          <ac:chgData name="Inmaculada Navarro Lérida" userId="a709f962-7a6b-4e29-94b4-34e94bec1ace" providerId="ADAL" clId="{CB1B0F86-67B5-48D7-A333-4A72740E5CDB}" dt="2025-12-07T15:21:06.807" v="31" actId="478"/>
          <ac:picMkLst>
            <pc:docMk/>
            <pc:sldMk cId="2265113984" sldId="256"/>
            <ac:picMk id="3" creationId="{8D5CBF44-524B-9A1F-D013-E137AD699FA8}"/>
          </ac:picMkLst>
        </pc:picChg>
        <pc:picChg chg="add mod modCrop">
          <ac:chgData name="Inmaculada Navarro Lérida" userId="a709f962-7a6b-4e29-94b4-34e94bec1ace" providerId="ADAL" clId="{CB1B0F86-67B5-48D7-A333-4A72740E5CDB}" dt="2025-12-07T15:23:18.985" v="54" actId="1076"/>
          <ac:picMkLst>
            <pc:docMk/>
            <pc:sldMk cId="2265113984" sldId="256"/>
            <ac:picMk id="4" creationId="{9C07D554-CF24-9AB6-0B3E-0B8C9B229ED4}"/>
          </ac:picMkLst>
        </pc:picChg>
        <pc:picChg chg="mod modCrop">
          <ac:chgData name="Inmaculada Navarro Lérida" userId="a709f962-7a6b-4e29-94b4-34e94bec1ace" providerId="ADAL" clId="{CB1B0F86-67B5-48D7-A333-4A72740E5CDB}" dt="2025-12-07T15:23:18.985" v="54" actId="1076"/>
          <ac:picMkLst>
            <pc:docMk/>
            <pc:sldMk cId="2265113984" sldId="256"/>
            <ac:picMk id="5" creationId="{F6BEF88F-F7D0-5BB9-D3EC-6CEAB22B3CA7}"/>
          </ac:picMkLst>
        </pc:picChg>
        <pc:picChg chg="add mod modCrop">
          <ac:chgData name="Inmaculada Navarro Lérida" userId="a709f962-7a6b-4e29-94b4-34e94bec1ace" providerId="ADAL" clId="{CB1B0F86-67B5-48D7-A333-4A72740E5CDB}" dt="2025-12-07T15:23:18.985" v="54" actId="1076"/>
          <ac:picMkLst>
            <pc:docMk/>
            <pc:sldMk cId="2265113984" sldId="256"/>
            <ac:picMk id="10" creationId="{D325A653-BFDA-CEEC-FB5D-CBEED0129ADC}"/>
          </ac:picMkLst>
        </pc:picChg>
        <pc:picChg chg="add mod modCrop">
          <ac:chgData name="Inmaculada Navarro Lérida" userId="a709f962-7a6b-4e29-94b4-34e94bec1ace" providerId="ADAL" clId="{CB1B0F86-67B5-48D7-A333-4A72740E5CDB}" dt="2025-12-07T15:23:18.985" v="54" actId="1076"/>
          <ac:picMkLst>
            <pc:docMk/>
            <pc:sldMk cId="2265113984" sldId="256"/>
            <ac:picMk id="11" creationId="{F44A5E4F-4DB8-4458-1BD9-F3C93589F9C5}"/>
          </ac:picMkLst>
        </pc:picChg>
        <pc:picChg chg="del mod">
          <ac:chgData name="Inmaculada Navarro Lérida" userId="a709f962-7a6b-4e29-94b4-34e94bec1ace" providerId="ADAL" clId="{CB1B0F86-67B5-48D7-A333-4A72740E5CDB}" dt="2025-12-07T15:23:10.334" v="51" actId="478"/>
          <ac:picMkLst>
            <pc:docMk/>
            <pc:sldMk cId="2265113984" sldId="256"/>
            <ac:picMk id="17" creationId="{E104BACD-240B-2486-79BE-C9F7470A7C4D}"/>
          </ac:picMkLst>
        </pc:picChg>
        <pc:cxnChg chg="add mod">
          <ac:chgData name="Inmaculada Navarro Lérida" userId="a709f962-7a6b-4e29-94b4-34e94bec1ace" providerId="ADAL" clId="{CB1B0F86-67B5-48D7-A333-4A72740E5CDB}" dt="2025-12-07T15:23:29.712" v="58" actId="13822"/>
          <ac:cxnSpMkLst>
            <pc:docMk/>
            <pc:sldMk cId="2265113984" sldId="256"/>
            <ac:cxnSpMk id="18" creationId="{83DFF899-D360-E605-31D3-5C7453D2F537}"/>
          </ac:cxnSpMkLst>
        </pc:cxnChg>
        <pc:cxnChg chg="add mod">
          <ac:chgData name="Inmaculada Navarro Lérida" userId="a709f962-7a6b-4e29-94b4-34e94bec1ace" providerId="ADAL" clId="{CB1B0F86-67B5-48D7-A333-4A72740E5CDB}" dt="2025-12-07T15:23:47.568" v="67" actId="1076"/>
          <ac:cxnSpMkLst>
            <pc:docMk/>
            <pc:sldMk cId="2265113984" sldId="256"/>
            <ac:cxnSpMk id="29" creationId="{27CEE0FB-D0D2-03C7-E354-336A09867D55}"/>
          </ac:cxnSpMkLst>
        </pc:cxnChg>
        <pc:cxnChg chg="add mod">
          <ac:chgData name="Inmaculada Navarro Lérida" userId="a709f962-7a6b-4e29-94b4-34e94bec1ace" providerId="ADAL" clId="{CB1B0F86-67B5-48D7-A333-4A72740E5CDB}" dt="2025-12-07T15:23:57.349" v="73" actId="1076"/>
          <ac:cxnSpMkLst>
            <pc:docMk/>
            <pc:sldMk cId="2265113984" sldId="256"/>
            <ac:cxnSpMk id="31" creationId="{AA5794AB-48FF-4E7C-52E9-DAAB8D6CBA63}"/>
          </ac:cxnSpMkLst>
        </pc:cxnChg>
        <pc:cxnChg chg="add mod">
          <ac:chgData name="Inmaculada Navarro Lérida" userId="a709f962-7a6b-4e29-94b4-34e94bec1ace" providerId="ADAL" clId="{CB1B0F86-67B5-48D7-A333-4A72740E5CDB}" dt="2025-12-07T15:24:07.292" v="79" actId="1076"/>
          <ac:cxnSpMkLst>
            <pc:docMk/>
            <pc:sldMk cId="2265113984" sldId="256"/>
            <ac:cxnSpMk id="33" creationId="{1EDB7EEA-1717-461A-6707-9ACB577997AA}"/>
          </ac:cxnSpMkLst>
        </pc:cxnChg>
        <pc:cxnChg chg="add mod">
          <ac:chgData name="Inmaculada Navarro Lérida" userId="a709f962-7a6b-4e29-94b4-34e94bec1ace" providerId="ADAL" clId="{CB1B0F86-67B5-48D7-A333-4A72740E5CDB}" dt="2025-12-07T15:24:16.139" v="85" actId="1076"/>
          <ac:cxnSpMkLst>
            <pc:docMk/>
            <pc:sldMk cId="2265113984" sldId="256"/>
            <ac:cxnSpMk id="35" creationId="{FE6790DB-0DBB-BD61-D6B9-D215B9B9331E}"/>
          </ac:cxnSpMkLst>
        </pc:cxnChg>
      </pc:sldChg>
      <pc:sldChg chg="add">
        <pc:chgData name="Inmaculada Navarro Lérida" userId="a709f962-7a6b-4e29-94b4-34e94bec1ace" providerId="ADAL" clId="{CB1B0F86-67B5-48D7-A333-4A72740E5CDB}" dt="2025-12-07T15:18:00.178" v="0" actId="2890"/>
        <pc:sldMkLst>
          <pc:docMk/>
          <pc:sldMk cId="2659087704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B785678-F85B-43A9-1B3F-5EAF12957F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A509E43-0F22-1704-4129-A491615553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8F87C5A-05DB-D6A1-A70A-5325E4642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05F2F9-9369-8E77-B8E2-9CA9332D1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F31A7E0-97D5-A2D3-11A8-E452825AE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4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B7D2BF-FB3E-02DE-F2E7-A213AD82C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4546643-1A76-AE53-421D-2B9C708E0A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B4DEA64-788F-A33F-67D7-08FCB06A9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E099B19-A48F-29EF-6D6B-D69B2E592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B8FF92D-61B9-73D8-F9F0-9B5F0926E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7975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441D6B7-EDD1-BB50-8314-FE10F98C3E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3352B76-6C01-B9B7-9E45-F5BA98C5E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6B5F36E-0F72-D16C-149C-765972207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253807D-C040-0132-DB91-A55CB8716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B0CD98E-7163-FC6B-4398-35C2F0A26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9601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90F52A2-FA68-8FBF-B5D6-DDD864EB2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FA34EE4-0E86-8026-9F0D-7C2B71B4BB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70FFF2-A3CE-C263-C80A-0DC78A1B6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52F6E67-ED2C-D6F8-128E-D0AE9A25A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07FB691-1893-4241-EF03-9FA820393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005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C96D11-AC80-1F79-DCCD-771A193BF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1267BFE-4E39-D6B7-B5D1-8AD702D16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C7D2B01-71FF-38FD-7563-9BF0C121D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F589403-07C3-C53C-DE20-B5F3C40B5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C615CE6-5EFE-D7B7-3FA2-42EA40501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3142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B20C94-EAA0-7009-4CCB-45C4B101DB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2F74A1A-AAE3-3BF5-0010-60A95581BF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373109E-DF29-E648-8F4B-1CF3B8AE9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E6E1CD4-59DF-D71E-AE5E-21BAD20DD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B8E2327-E00F-6EA5-EF1F-CF7206D52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FECFC38-1128-D404-B682-672B2EDD5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9012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06625B9-4980-F55B-64C5-B05F4E2CA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ED21924-0396-93D4-E5C8-0A8185C90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343A172-E33C-585B-69D8-0A834AF098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C6801CA-896E-E6B9-D9F9-95A7D7A30F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15DFB08-765F-312F-47C9-C0CFCE774B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5850393-FBCA-3137-F662-29C03E7FC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011382F-A025-F072-BEAE-D262191B8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8214EE5-86B3-19F9-28EA-BC14BAA03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0330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F12B6D-6024-FD1D-34F8-21348826C4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BD09759-6D70-691B-6086-EB2CE482F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65BEAA2-41FB-23A2-E6D8-E7069B7FD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89F2875-B2BE-A652-F93E-B492C9740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754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9740544-741B-1131-F598-1BDAF6D36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7D95BBF-575C-D2B2-9EF4-6E7708181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E213C6D-9589-DD59-E7B6-175797766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589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BAFC34-5E4C-3967-E4B1-8F8D7C8BB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3F4BE2F-DBBE-489A-E4E4-3AC1198B8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C472FF6-08FA-C41D-396A-24ECAEEC4A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F72432B-5045-8435-0BAE-E1D6E09EB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C638215-0FF0-D6F1-8DE4-C94F3B6D9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3B0003C-BB64-4535-E335-CAA2B7197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1409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05B748-0EB7-A526-FA95-942F8B9D6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4BB8318-9842-6503-01EE-E6AE4A6D35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6AD2155-352A-B882-CFDE-730A8E27E7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67385C1-2BAF-13F5-BFAB-ADEC5C83B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12563D9-BD56-EFDC-0D00-0FDAB022C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B03DE15-125C-A588-555A-BFDED55DB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397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78C5A1F-1456-9DE5-DC22-B4EC9881A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1729286-61ED-4F24-9F07-02510DEAC8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A109D31-9327-9833-915B-3BA940CBF4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BAA9D7-515A-4F9F-BF06-C4479B8CF664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A587EE-A7BC-E4A4-7EB6-F80FD67A10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5C3FE68-444A-E218-F380-14672CD914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C82017-9DC1-4B75-8522-2C115C742A2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996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F6BEF88F-F7D0-5BB9-D3EC-6CEAB22B3CA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0899" t="46318" r="48490" b="11501"/>
          <a:stretch>
            <a:fillRect/>
          </a:stretch>
        </p:blipFill>
        <p:spPr>
          <a:xfrm rot="16200000">
            <a:off x="2458222" y="3793378"/>
            <a:ext cx="779929" cy="1483659"/>
          </a:xfrm>
          <a:prstGeom prst="rect">
            <a:avLst/>
          </a:prstGeom>
        </p:spPr>
      </p:pic>
      <p:pic>
        <p:nvPicPr>
          <p:cNvPr id="2" name="Imagen 1">
            <a:extLst>
              <a:ext uri="{FF2B5EF4-FFF2-40B4-BE49-F238E27FC236}">
                <a16:creationId xmlns:a16="http://schemas.microsoft.com/office/drawing/2014/main" id="{4B40D47B-FC90-73C2-E7E3-A66FB29748C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036" t="1278" r="37706" b="55267"/>
          <a:stretch>
            <a:fillRect/>
          </a:stretch>
        </p:blipFill>
        <p:spPr>
          <a:xfrm rot="16200000">
            <a:off x="2220306" y="4505971"/>
            <a:ext cx="891311" cy="1806860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9C07D554-CF24-9AB6-0B3E-0B8C9B229ED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167" t="46778" r="33625" b="14737"/>
          <a:stretch>
            <a:fillRect/>
          </a:stretch>
        </p:blipFill>
        <p:spPr>
          <a:xfrm rot="16200000">
            <a:off x="2389647" y="2866336"/>
            <a:ext cx="1126997" cy="1353671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D325A653-BFDA-CEEC-FB5D-CBEED0129AD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0074" t="76226" r="50289" b="1922"/>
          <a:stretch>
            <a:fillRect/>
          </a:stretch>
        </p:blipFill>
        <p:spPr>
          <a:xfrm>
            <a:off x="1978830" y="2051971"/>
            <a:ext cx="1694740" cy="897090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F44A5E4F-4DB8-4458-1BD9-F3C93589F9C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8309" t="5608" r="50744" b="76051"/>
          <a:stretch>
            <a:fillRect/>
          </a:stretch>
        </p:blipFill>
        <p:spPr>
          <a:xfrm>
            <a:off x="1921784" y="1236742"/>
            <a:ext cx="1808832" cy="753339"/>
          </a:xfrm>
          <a:prstGeom prst="rect">
            <a:avLst/>
          </a:prstGeom>
        </p:spPr>
      </p:pic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83DFF899-D360-E605-31D3-5C7453D2F537}"/>
              </a:ext>
            </a:extLst>
          </p:cNvPr>
          <p:cNvCxnSpPr>
            <a:cxnSpLocks/>
          </p:cNvCxnSpPr>
          <p:nvPr/>
        </p:nvCxnSpPr>
        <p:spPr>
          <a:xfrm flipH="1">
            <a:off x="3673570" y="1650381"/>
            <a:ext cx="2516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id="{ECAB8D97-4B70-876C-F8B2-AB06E20ECCAF}"/>
              </a:ext>
            </a:extLst>
          </p:cNvPr>
          <p:cNvSpPr txBox="1"/>
          <p:nvPr/>
        </p:nvSpPr>
        <p:spPr>
          <a:xfrm>
            <a:off x="3925229" y="1465715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PDGFR</a:t>
            </a:r>
          </a:p>
        </p:txBody>
      </p: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27CEE0FB-D0D2-03C7-E354-336A09867D55}"/>
              </a:ext>
            </a:extLst>
          </p:cNvPr>
          <p:cNvCxnSpPr>
            <a:cxnSpLocks/>
          </p:cNvCxnSpPr>
          <p:nvPr/>
        </p:nvCxnSpPr>
        <p:spPr>
          <a:xfrm flipH="1">
            <a:off x="3673570" y="2438401"/>
            <a:ext cx="2516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" name="CuadroTexto 29">
            <a:extLst>
              <a:ext uri="{FF2B5EF4-FFF2-40B4-BE49-F238E27FC236}">
                <a16:creationId xmlns:a16="http://schemas.microsoft.com/office/drawing/2014/main" id="{99654C19-C3BB-E974-4F54-CB2813EA16A5}"/>
              </a:ext>
            </a:extLst>
          </p:cNvPr>
          <p:cNvSpPr txBox="1"/>
          <p:nvPr/>
        </p:nvSpPr>
        <p:spPr>
          <a:xfrm>
            <a:off x="3925229" y="2253735"/>
            <a:ext cx="695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av1</a:t>
            </a:r>
          </a:p>
        </p:txBody>
      </p:sp>
      <p:cxnSp>
        <p:nvCxnSpPr>
          <p:cNvPr id="31" name="Conector recto de flecha 30">
            <a:extLst>
              <a:ext uri="{FF2B5EF4-FFF2-40B4-BE49-F238E27FC236}">
                <a16:creationId xmlns:a16="http://schemas.microsoft.com/office/drawing/2014/main" id="{AA5794AB-48FF-4E7C-52E9-DAAB8D6CBA63}"/>
              </a:ext>
            </a:extLst>
          </p:cNvPr>
          <p:cNvCxnSpPr>
            <a:cxnSpLocks/>
          </p:cNvCxnSpPr>
          <p:nvPr/>
        </p:nvCxnSpPr>
        <p:spPr>
          <a:xfrm flipH="1">
            <a:off x="3693832" y="3680574"/>
            <a:ext cx="2516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71B5CF1-E4E7-F2F6-A47A-3C9F42D47206}"/>
              </a:ext>
            </a:extLst>
          </p:cNvPr>
          <p:cNvSpPr txBox="1"/>
          <p:nvPr/>
        </p:nvSpPr>
        <p:spPr>
          <a:xfrm>
            <a:off x="3945491" y="3495908"/>
            <a:ext cx="685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PTRF</a:t>
            </a:r>
          </a:p>
        </p:txBody>
      </p:sp>
      <p:cxnSp>
        <p:nvCxnSpPr>
          <p:cNvPr id="33" name="Conector recto de flecha 32">
            <a:extLst>
              <a:ext uri="{FF2B5EF4-FFF2-40B4-BE49-F238E27FC236}">
                <a16:creationId xmlns:a16="http://schemas.microsoft.com/office/drawing/2014/main" id="{1EDB7EEA-1717-461A-6707-9ACB577997AA}"/>
              </a:ext>
            </a:extLst>
          </p:cNvPr>
          <p:cNvCxnSpPr>
            <a:cxnSpLocks/>
          </p:cNvCxnSpPr>
          <p:nvPr/>
        </p:nvCxnSpPr>
        <p:spPr>
          <a:xfrm flipH="1">
            <a:off x="3673570" y="4469266"/>
            <a:ext cx="2516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CuadroTexto 33">
            <a:extLst>
              <a:ext uri="{FF2B5EF4-FFF2-40B4-BE49-F238E27FC236}">
                <a16:creationId xmlns:a16="http://schemas.microsoft.com/office/drawing/2014/main" id="{739FA583-71D6-94E2-54EA-E3DA178298B9}"/>
              </a:ext>
            </a:extLst>
          </p:cNvPr>
          <p:cNvSpPr txBox="1"/>
          <p:nvPr/>
        </p:nvSpPr>
        <p:spPr>
          <a:xfrm>
            <a:off x="3925229" y="4284600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lix</a:t>
            </a:r>
          </a:p>
        </p:txBody>
      </p:sp>
      <p:cxnSp>
        <p:nvCxnSpPr>
          <p:cNvPr id="35" name="Conector recto de flecha 34">
            <a:extLst>
              <a:ext uri="{FF2B5EF4-FFF2-40B4-BE49-F238E27FC236}">
                <a16:creationId xmlns:a16="http://schemas.microsoft.com/office/drawing/2014/main" id="{FE6790DB-0DBB-BD61-D6B9-D215B9B9331E}"/>
              </a:ext>
            </a:extLst>
          </p:cNvPr>
          <p:cNvCxnSpPr>
            <a:cxnSpLocks/>
          </p:cNvCxnSpPr>
          <p:nvPr/>
        </p:nvCxnSpPr>
        <p:spPr>
          <a:xfrm flipH="1">
            <a:off x="3628993" y="5383073"/>
            <a:ext cx="2516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E392F076-F41E-A84D-E226-1878E2D1B3DE}"/>
              </a:ext>
            </a:extLst>
          </p:cNvPr>
          <p:cNvSpPr txBox="1"/>
          <p:nvPr/>
        </p:nvSpPr>
        <p:spPr>
          <a:xfrm>
            <a:off x="3880652" y="5198407"/>
            <a:ext cx="955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TSG101</a:t>
            </a:r>
          </a:p>
        </p:txBody>
      </p:sp>
      <p:sp>
        <p:nvSpPr>
          <p:cNvPr id="37" name="Rectángulo 36">
            <a:extLst>
              <a:ext uri="{FF2B5EF4-FFF2-40B4-BE49-F238E27FC236}">
                <a16:creationId xmlns:a16="http://schemas.microsoft.com/office/drawing/2014/main" id="{BF92DF8A-1BC9-4F4C-B40B-EBECADDA3165}"/>
              </a:ext>
            </a:extLst>
          </p:cNvPr>
          <p:cNvSpPr/>
          <p:nvPr/>
        </p:nvSpPr>
        <p:spPr>
          <a:xfrm>
            <a:off x="2364059" y="1382751"/>
            <a:ext cx="981307" cy="4522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E7D03140-4342-6580-BE31-F295A7C504B4}"/>
              </a:ext>
            </a:extLst>
          </p:cNvPr>
          <p:cNvSpPr/>
          <p:nvPr/>
        </p:nvSpPr>
        <p:spPr>
          <a:xfrm>
            <a:off x="2364058" y="2206119"/>
            <a:ext cx="981307" cy="4522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" name="Rectángulo 38">
            <a:extLst>
              <a:ext uri="{FF2B5EF4-FFF2-40B4-BE49-F238E27FC236}">
                <a16:creationId xmlns:a16="http://schemas.microsoft.com/office/drawing/2014/main" id="{AA24F812-6324-D67B-EB43-12493F7B737C}"/>
              </a:ext>
            </a:extLst>
          </p:cNvPr>
          <p:cNvSpPr/>
          <p:nvPr/>
        </p:nvSpPr>
        <p:spPr>
          <a:xfrm>
            <a:off x="2335546" y="3481169"/>
            <a:ext cx="981307" cy="4522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" name="Rectángulo 39">
            <a:extLst>
              <a:ext uri="{FF2B5EF4-FFF2-40B4-BE49-F238E27FC236}">
                <a16:creationId xmlns:a16="http://schemas.microsoft.com/office/drawing/2014/main" id="{CA21EAE1-1FD7-A64C-B461-82195A63E1D2}"/>
              </a:ext>
            </a:extLst>
          </p:cNvPr>
          <p:cNvSpPr/>
          <p:nvPr/>
        </p:nvSpPr>
        <p:spPr>
          <a:xfrm>
            <a:off x="2386720" y="4266021"/>
            <a:ext cx="981307" cy="4522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CBE00172-D586-8DC8-5C88-508AC6188019}"/>
              </a:ext>
            </a:extLst>
          </p:cNvPr>
          <p:cNvSpPr/>
          <p:nvPr/>
        </p:nvSpPr>
        <p:spPr>
          <a:xfrm>
            <a:off x="2335546" y="5156927"/>
            <a:ext cx="981307" cy="4522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3FA3C7F8-0E96-4C51-1066-17BAC6C77ECF}"/>
              </a:ext>
            </a:extLst>
          </p:cNvPr>
          <p:cNvSpPr txBox="1"/>
          <p:nvPr/>
        </p:nvSpPr>
        <p:spPr>
          <a:xfrm rot="18568017">
            <a:off x="2273316" y="574994"/>
            <a:ext cx="1124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NFsh</a:t>
            </a:r>
            <a:r>
              <a:rPr lang="es-ES" dirty="0"/>
              <a:t> </a:t>
            </a:r>
            <a:r>
              <a:rPr lang="es-ES" dirty="0" err="1"/>
              <a:t>Ctrl</a:t>
            </a:r>
            <a:endParaRPr lang="es-ES" dirty="0"/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E2C513AF-A9A1-92E9-05D0-30A9FA14A1C6}"/>
              </a:ext>
            </a:extLst>
          </p:cNvPr>
          <p:cNvSpPr txBox="1"/>
          <p:nvPr/>
        </p:nvSpPr>
        <p:spPr>
          <a:xfrm rot="18568017">
            <a:off x="2874157" y="584769"/>
            <a:ext cx="1045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NFsh</a:t>
            </a:r>
            <a:r>
              <a:rPr lang="es-ES" dirty="0"/>
              <a:t> </a:t>
            </a:r>
            <a:r>
              <a:rPr lang="es-ES" dirty="0" err="1"/>
              <a:t>Gq</a:t>
            </a:r>
            <a:endParaRPr lang="es-ES" dirty="0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4CDBCC1A-C6C8-B730-5768-CB392783E359}"/>
              </a:ext>
            </a:extLst>
          </p:cNvPr>
          <p:cNvSpPr txBox="1"/>
          <p:nvPr/>
        </p:nvSpPr>
        <p:spPr>
          <a:xfrm>
            <a:off x="9333571" y="501805"/>
            <a:ext cx="10917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/>
              <a:t>Figure 7E</a:t>
            </a:r>
          </a:p>
        </p:txBody>
      </p:sp>
    </p:spTree>
    <p:extLst>
      <p:ext uri="{BB962C8B-B14F-4D97-AF65-F5344CB8AC3E}">
        <p14:creationId xmlns:p14="http://schemas.microsoft.com/office/powerpoint/2010/main" val="2265113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3F4559-6C4F-F216-A0A9-DFD099AD42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>
            <a:extLst>
              <a:ext uri="{FF2B5EF4-FFF2-40B4-BE49-F238E27FC236}">
                <a16:creationId xmlns:a16="http://schemas.microsoft.com/office/drawing/2014/main" id="{8FAD3B34-F125-CF08-8486-D06989AB562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074" r="30175"/>
          <a:stretch>
            <a:fillRect/>
          </a:stretch>
        </p:blipFill>
        <p:spPr>
          <a:xfrm>
            <a:off x="4878069" y="117932"/>
            <a:ext cx="3432544" cy="4107536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E015C74D-4F99-8ADD-117D-AF02E449C15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359" r="33516"/>
          <a:stretch>
            <a:fillRect/>
          </a:stretch>
        </p:blipFill>
        <p:spPr>
          <a:xfrm>
            <a:off x="638175" y="217548"/>
            <a:ext cx="2434658" cy="3517396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EDB16BA2-E26F-FD25-4F31-9364A914F899}"/>
              </a:ext>
            </a:extLst>
          </p:cNvPr>
          <p:cNvSpPr/>
          <p:nvPr/>
        </p:nvSpPr>
        <p:spPr>
          <a:xfrm>
            <a:off x="1481328" y="2171700"/>
            <a:ext cx="271272" cy="838200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E248ECB1-5AB0-9D20-F058-68967B406AB3}"/>
              </a:ext>
            </a:extLst>
          </p:cNvPr>
          <p:cNvSpPr txBox="1"/>
          <p:nvPr/>
        </p:nvSpPr>
        <p:spPr>
          <a:xfrm>
            <a:off x="1318177" y="3328416"/>
            <a:ext cx="460382" cy="30777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400" dirty="0"/>
              <a:t>Alix</a:t>
            </a:r>
            <a:endParaRPr lang="es-ES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AE78090-592C-760D-2A17-3B9437BDB2DF}"/>
              </a:ext>
            </a:extLst>
          </p:cNvPr>
          <p:cNvSpPr txBox="1"/>
          <p:nvPr/>
        </p:nvSpPr>
        <p:spPr>
          <a:xfrm>
            <a:off x="638175" y="2155341"/>
            <a:ext cx="76014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Ctrl</a:t>
            </a:r>
            <a:endParaRPr lang="es-ES" sz="11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78870019-3149-C494-37EF-5F5B04B4DB50}"/>
              </a:ext>
            </a:extLst>
          </p:cNvPr>
          <p:cNvSpPr txBox="1"/>
          <p:nvPr/>
        </p:nvSpPr>
        <p:spPr>
          <a:xfrm>
            <a:off x="638175" y="2689300"/>
            <a:ext cx="71205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Gq</a:t>
            </a:r>
            <a:endParaRPr lang="es-ES" sz="11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300E17D-07B7-2340-F375-F56BFD6299A2}"/>
              </a:ext>
            </a:extLst>
          </p:cNvPr>
          <p:cNvSpPr txBox="1"/>
          <p:nvPr/>
        </p:nvSpPr>
        <p:spPr>
          <a:xfrm>
            <a:off x="4878069" y="3007816"/>
            <a:ext cx="76014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Ctrl</a:t>
            </a:r>
            <a:endParaRPr lang="es-ES" sz="110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62D202B5-827C-3E04-D459-C28DD9320EB8}"/>
              </a:ext>
            </a:extLst>
          </p:cNvPr>
          <p:cNvSpPr txBox="1"/>
          <p:nvPr/>
        </p:nvSpPr>
        <p:spPr>
          <a:xfrm>
            <a:off x="5739973" y="3007816"/>
            <a:ext cx="71205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Gq</a:t>
            </a:r>
            <a:endParaRPr lang="es-ES" sz="1100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F8563B5-5104-A1EE-C828-D83CD6D5E491}"/>
              </a:ext>
            </a:extLst>
          </p:cNvPr>
          <p:cNvSpPr txBox="1"/>
          <p:nvPr/>
        </p:nvSpPr>
        <p:spPr>
          <a:xfrm>
            <a:off x="5472755" y="3917691"/>
            <a:ext cx="583621" cy="30777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400" dirty="0"/>
              <a:t>Cav1</a:t>
            </a:r>
            <a:endParaRPr lang="es-ES" dirty="0"/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B3D1E12E-7ED8-4A9E-089A-416BED1759A2}"/>
              </a:ext>
            </a:extLst>
          </p:cNvPr>
          <p:cNvSpPr/>
          <p:nvPr/>
        </p:nvSpPr>
        <p:spPr>
          <a:xfrm rot="16200000">
            <a:off x="5571543" y="3204269"/>
            <a:ext cx="369332" cy="838200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A384B6CF-D99E-636D-D950-9D239CA88F0A}"/>
              </a:ext>
            </a:extLst>
          </p:cNvPr>
          <p:cNvSpPr/>
          <p:nvPr/>
        </p:nvSpPr>
        <p:spPr>
          <a:xfrm rot="16200000">
            <a:off x="5452610" y="311717"/>
            <a:ext cx="369332" cy="838200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1052D1BD-10B9-F888-65CC-24425AC80353}"/>
              </a:ext>
            </a:extLst>
          </p:cNvPr>
          <p:cNvSpPr txBox="1"/>
          <p:nvPr/>
        </p:nvSpPr>
        <p:spPr>
          <a:xfrm>
            <a:off x="4838104" y="91249"/>
            <a:ext cx="76014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Ctrl</a:t>
            </a:r>
            <a:endParaRPr lang="es-ES" sz="1100" dirty="0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16687B5E-311E-E67B-F4C9-79EEE7C4706C}"/>
              </a:ext>
            </a:extLst>
          </p:cNvPr>
          <p:cNvSpPr txBox="1"/>
          <p:nvPr/>
        </p:nvSpPr>
        <p:spPr>
          <a:xfrm>
            <a:off x="5700008" y="91249"/>
            <a:ext cx="71205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Gq</a:t>
            </a:r>
            <a:endParaRPr lang="es-ES" sz="1100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2C5E3E86-3971-0216-1899-34CA088B4D83}"/>
              </a:ext>
            </a:extLst>
          </p:cNvPr>
          <p:cNvSpPr txBox="1"/>
          <p:nvPr/>
        </p:nvSpPr>
        <p:spPr>
          <a:xfrm>
            <a:off x="5321528" y="946260"/>
            <a:ext cx="742511" cy="30777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400" dirty="0"/>
              <a:t>PDGFR</a:t>
            </a:r>
            <a:endParaRPr lang="es-ES" dirty="0"/>
          </a:p>
        </p:txBody>
      </p:sp>
      <p:sp>
        <p:nvSpPr>
          <p:cNvPr id="25" name="Rectángulo 24">
            <a:extLst>
              <a:ext uri="{FF2B5EF4-FFF2-40B4-BE49-F238E27FC236}">
                <a16:creationId xmlns:a16="http://schemas.microsoft.com/office/drawing/2014/main" id="{3CD3AE3E-F71F-33C7-9ABA-40E0F359E3D5}"/>
              </a:ext>
            </a:extLst>
          </p:cNvPr>
          <p:cNvSpPr/>
          <p:nvPr/>
        </p:nvSpPr>
        <p:spPr>
          <a:xfrm>
            <a:off x="2237232" y="746056"/>
            <a:ext cx="271272" cy="780992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77C401A-E16C-3A56-2DE0-6CB97EB576CD}"/>
              </a:ext>
            </a:extLst>
          </p:cNvPr>
          <p:cNvSpPr txBox="1"/>
          <p:nvPr/>
        </p:nvSpPr>
        <p:spPr>
          <a:xfrm>
            <a:off x="2756771" y="720078"/>
            <a:ext cx="76014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Ctrl</a:t>
            </a:r>
            <a:endParaRPr lang="es-ES" sz="1100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EF3BFDA1-18A6-DE4F-E67D-3B53BF5C19AD}"/>
              </a:ext>
            </a:extLst>
          </p:cNvPr>
          <p:cNvSpPr txBox="1"/>
          <p:nvPr/>
        </p:nvSpPr>
        <p:spPr>
          <a:xfrm>
            <a:off x="2756771" y="1254037"/>
            <a:ext cx="712054" cy="43088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100" dirty="0"/>
              <a:t>Exos</a:t>
            </a:r>
          </a:p>
          <a:p>
            <a:r>
              <a:rPr lang="es-ES" sz="1100" dirty="0"/>
              <a:t>NF </a:t>
            </a:r>
            <a:r>
              <a:rPr lang="es-ES" sz="1100" dirty="0" err="1"/>
              <a:t>shGq</a:t>
            </a:r>
            <a:endParaRPr lang="es-ES" sz="11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F3C86D2-B730-CA2F-2DC7-6585703183AC}"/>
              </a:ext>
            </a:extLst>
          </p:cNvPr>
          <p:cNvSpPr txBox="1"/>
          <p:nvPr/>
        </p:nvSpPr>
        <p:spPr>
          <a:xfrm>
            <a:off x="2172256" y="1663456"/>
            <a:ext cx="723981" cy="307777"/>
          </a:xfrm>
          <a:prstGeom prst="rect">
            <a:avLst/>
          </a:prstGeom>
          <a:ln>
            <a:noFill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ES" sz="1400" dirty="0"/>
              <a:t>Tsg101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590877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9</Words>
  <Application>Microsoft Office PowerPoint</Application>
  <PresentationFormat>Panorámica</PresentationFormat>
  <Paragraphs>28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Huertas Larez</dc:creator>
  <cp:lastModifiedBy>Inmaculada Navarro Lérida</cp:lastModifiedBy>
  <cp:revision>1</cp:revision>
  <dcterms:created xsi:type="dcterms:W3CDTF">2025-12-04T11:51:45Z</dcterms:created>
  <dcterms:modified xsi:type="dcterms:W3CDTF">2025-12-07T15:25:51Z</dcterms:modified>
</cp:coreProperties>
</file>